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70777-C741-4EEB-9D3D-0B7F97046E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934CD-1F4C-43B5-99A7-450DFCDDA4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643EF-8648-44F3-83F0-22009624D4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A4156-97CD-409A-9A3F-A6FD930C02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0021C-96EB-4ADD-9290-0ADC6D6D0B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B2A37-6D0D-4C83-9358-6B6AEA931D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956A2-B8C4-43AD-9F3F-16C87D2EA7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C7858-9788-42CB-905C-607E94A6AD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1F8AA-38C4-491C-86A6-39FB3EB5CC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881E7-7D81-4FD0-BB5B-7E17229BDB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C75B5-A0CF-4C45-94DB-EB464EDAF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E7D6E-CB6C-48D7-A645-6BA8E881A6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90FA8E-4E65-4131-8246-E392A1D610D9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557360" y="571680"/>
            <a:ext cx="2857320" cy="831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SPERM PREPA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(IVF Preparation Techniqu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SAMPLE 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(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Undetermined Function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CONTROL (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Fertile Donors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1557360" y="2214720"/>
            <a:ext cx="2857320" cy="6429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CONTROL AND SAMPLE DROPLETS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with fixed sperm concent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1557360" y="3929040"/>
            <a:ext cx="2857320" cy="6429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CO-INCUB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of processed sperm with hemizo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565280" y="5429160"/>
            <a:ext cx="2857320" cy="6429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MICROSCOP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7"/>
          <p:cNvSpPr/>
          <p:nvPr/>
        </p:nvSpPr>
        <p:spPr>
          <a:xfrm>
            <a:off x="2987640" y="1425600"/>
            <a:ext cx="0" cy="760320"/>
          </a:xfrm>
          <a:prstGeom prst="line">
            <a:avLst/>
          </a:prstGeom>
          <a:ln w="25560">
            <a:solidFill>
              <a:srgbClr val="9c9cdf">
                <a:alpha val="60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8"/>
          <p:cNvSpPr/>
          <p:nvPr/>
        </p:nvSpPr>
        <p:spPr>
          <a:xfrm>
            <a:off x="2987640" y="2852640"/>
            <a:ext cx="0" cy="1046160"/>
          </a:xfrm>
          <a:prstGeom prst="line">
            <a:avLst/>
          </a:prstGeom>
          <a:ln w="25560">
            <a:solidFill>
              <a:srgbClr val="9c9cdf">
                <a:alpha val="60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9"/>
          <p:cNvSpPr/>
          <p:nvPr/>
        </p:nvSpPr>
        <p:spPr>
          <a:xfrm flipH="1">
            <a:off x="2987280" y="4581360"/>
            <a:ext cx="4680" cy="831960"/>
          </a:xfrm>
          <a:prstGeom prst="line">
            <a:avLst/>
          </a:prstGeom>
          <a:ln w="25560">
            <a:solidFill>
              <a:srgbClr val="9c9cdf">
                <a:alpha val="60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3841920" y="3063960"/>
            <a:ext cx="3230280" cy="64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MICRODISSECTION OF UNFERTILISED OOCYT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into two equal halves for differential expos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4721400" y="5416560"/>
            <a:ext cx="2857320" cy="642960"/>
          </a:xfrm>
          <a:prstGeom prst="rect">
            <a:avLst/>
          </a:prstGeom>
          <a:solidFill>
            <a:srgbClr val="748ab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Hemizona Index (HZ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[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No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of  Bound Spermatozoa (Sample)/ No of Bound Spermatozoa (Control)] x 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2"/>
          <p:cNvSpPr/>
          <p:nvPr/>
        </p:nvSpPr>
        <p:spPr>
          <a:xfrm flipH="1">
            <a:off x="4427280" y="5734080"/>
            <a:ext cx="285480" cy="0"/>
          </a:xfrm>
          <a:prstGeom prst="line">
            <a:avLst/>
          </a:prstGeom>
          <a:ln w="25560">
            <a:solidFill>
              <a:srgbClr val="9c9cdf">
                <a:alpha val="60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eft Arrow 13"/>
          <p:cNvSpPr/>
          <p:nvPr/>
        </p:nvSpPr>
        <p:spPr>
          <a:xfrm>
            <a:off x="3427560" y="3268800"/>
            <a:ext cx="357120" cy="214200"/>
          </a:xfrm>
          <a:prstGeom prst="leftArrow">
            <a:avLst>
              <a:gd name="adj1" fmla="val 50000"/>
              <a:gd name="adj2" fmla="val 50017"/>
            </a:avLst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8T04:55:15Z</dcterms:created>
  <dc:creator>user</dc:creator>
  <dc:description/>
  <dc:language>en-US</dc:language>
  <cp:lastModifiedBy>Admin</cp:lastModifiedBy>
  <dcterms:modified xsi:type="dcterms:W3CDTF">2013-02-09T20:12:03Z</dcterms:modified>
  <cp:revision>61</cp:revision>
  <dc:subject/>
  <dc:title>Διαφάνεια 1</dc:title>
</cp:coreProperties>
</file>